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9"/>
  </p:notesMasterIdLst>
  <p:sldIdLst>
    <p:sldId id="1096" r:id="rId2"/>
    <p:sldId id="1073" r:id="rId3"/>
    <p:sldId id="1084" r:id="rId4"/>
    <p:sldId id="1093" r:id="rId5"/>
    <p:sldId id="1094" r:id="rId6"/>
    <p:sldId id="1080" r:id="rId7"/>
    <p:sldId id="1090" r:id="rId8"/>
    <p:sldId id="1077" r:id="rId9"/>
    <p:sldId id="1092" r:id="rId10"/>
    <p:sldId id="1095" r:id="rId11"/>
    <p:sldId id="1075" r:id="rId12"/>
    <p:sldId id="1083" r:id="rId13"/>
    <p:sldId id="1088" r:id="rId14"/>
    <p:sldId id="1087" r:id="rId15"/>
    <p:sldId id="1089" r:id="rId16"/>
    <p:sldId id="1058" r:id="rId17"/>
    <p:sldId id="1078" r:id="rId18"/>
  </p:sldIdLst>
  <p:sldSz cx="18288000" cy="10287000"/>
  <p:notesSz cx="6858000" cy="9144000"/>
  <p:embeddedFontLst>
    <p:embeddedFont>
      <p:font typeface="Assistant" pitchFamily="2" charset="-79"/>
      <p:regular r:id="rId20"/>
      <p:bold r:id="rId21"/>
    </p:embeddedFont>
    <p:embeddedFont>
      <p:font typeface="Assistant Bold" charset="-79"/>
      <p:regular r:id="rId22"/>
      <p:bold r:id="rId23"/>
    </p:embeddedFont>
    <p:embeddedFont>
      <p:font typeface="Assistant ExtraBold" pitchFamily="2" charset="-79"/>
      <p:bold r:id="rId24"/>
    </p:embeddedFont>
    <p:embeddedFont>
      <p:font typeface="Assistant Regular" charset="-79"/>
      <p:regular r:id="rId25"/>
    </p:embeddedFont>
    <p:embeddedFont>
      <p:font typeface="Assistant SemiBold" pitchFamily="2" charset="-79"/>
      <p:bold r:id="rId26"/>
    </p:embeddedFont>
    <p:embeddedFont>
      <p:font typeface="Calibri" panose="020F0502020204030204" pitchFamily="34" charset="0"/>
      <p:regular r:id="rId27"/>
      <p:bold r:id="rId28"/>
      <p:italic r:id="rId29"/>
      <p:boldItalic r:id="rId30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1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font" Target="fonts/font7.fntdata"/><Relationship Id="rId3" Type="http://schemas.openxmlformats.org/officeDocument/2006/relationships/slide" Target="slides/slide2.xml"/><Relationship Id="rId21" Type="http://schemas.openxmlformats.org/officeDocument/2006/relationships/font" Target="fonts/font2.fntdata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font" Target="fonts/font6.fntdata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font" Target="fonts/font1.fntdata"/><Relationship Id="rId29" Type="http://schemas.openxmlformats.org/officeDocument/2006/relationships/font" Target="fonts/font10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5.fntdata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4.fntdata"/><Relationship Id="rId28" Type="http://schemas.openxmlformats.org/officeDocument/2006/relationships/font" Target="fonts/font9.fntdata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3.fntdata"/><Relationship Id="rId27" Type="http://schemas.openxmlformats.org/officeDocument/2006/relationships/font" Target="fonts/font8.fntdata"/><Relationship Id="rId30" Type="http://schemas.openxmlformats.org/officeDocument/2006/relationships/font" Target="fonts/font11.fntdata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22125431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9511650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67319969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03730406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944310756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0922531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8348568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29987147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01942048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0774151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svg"/><Relationship Id="rId4" Type="http://schemas.openxmlformats.org/officeDocument/2006/relationships/image" Target="../media/image18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sv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svg"/><Relationship Id="rId5" Type="http://schemas.openxmlformats.org/officeDocument/2006/relationships/image" Target="../media/image26.png"/><Relationship Id="rId4" Type="http://schemas.openxmlformats.org/officeDocument/2006/relationships/image" Target="../media/image25.sv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jpeg"/><Relationship Id="rId4" Type="http://schemas.openxmlformats.org/officeDocument/2006/relationships/image" Target="../media/image5.sv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eg"/><Relationship Id="rId4" Type="http://schemas.openxmlformats.org/officeDocument/2006/relationships/image" Target="../media/image5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5" Type="http://schemas.openxmlformats.org/officeDocument/2006/relationships/image" Target="../media/image7.jpeg"/><Relationship Id="rId4" Type="http://schemas.openxmlformats.org/officeDocument/2006/relationships/image" Target="../media/image5.sv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eg"/><Relationship Id="rId4" Type="http://schemas.openxmlformats.org/officeDocument/2006/relationships/image" Target="../media/image15.sv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2069383"/>
            <a:chOff x="1573698" y="-152998"/>
            <a:chExt cx="7219847" cy="1987255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1846660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9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Conquer Negativity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en are you most likely to slip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445792" y="2157243"/>
            <a:ext cx="10266486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Different situations may be more and less difficult for you to stay on track of physical activity-- choose one:</a:t>
            </a:r>
          </a:p>
          <a:p>
            <a:endParaRPr lang="en-US" sz="3600" dirty="0"/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at work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on vacation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visiting with friends and family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feeling blue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the weather is crummy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Other (discuss)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600" dirty="0"/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600" dirty="0"/>
          </a:p>
          <a:p>
            <a:pPr lvl="1"/>
            <a:endParaRPr lang="en-US" sz="3600" dirty="0"/>
          </a:p>
        </p:txBody>
      </p:sp>
      <p:pic>
        <p:nvPicPr>
          <p:cNvPr id="2050" name="Picture 2" descr="Mountain climber summiting snowy peak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881413" y="2961699"/>
            <a:ext cx="5456903" cy="36310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Graphic 5" descr="Aspiration with solid fill">
            <a:extLst>
              <a:ext uri="{FF2B5EF4-FFF2-40B4-BE49-F238E27FC236}">
                <a16:creationId xmlns:a16="http://schemas.microsoft.com/office/drawing/2014/main" id="{76ACE230-24B1-4FCB-9841-6DF4D664B7D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752600" y="7962900"/>
            <a:ext cx="2057400" cy="20574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5FA1651-C96B-44CB-A028-72C291D4C403}"/>
              </a:ext>
            </a:extLst>
          </p:cNvPr>
          <p:cNvSpPr txBox="1"/>
          <p:nvPr/>
        </p:nvSpPr>
        <p:spPr>
          <a:xfrm>
            <a:off x="3810000" y="8645360"/>
            <a:ext cx="128778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Now you know some of your predictable and preventable obstacles that might lead to a slip.  What can you do to plan for success when these obstacles are on your path?</a:t>
            </a:r>
          </a:p>
        </p:txBody>
      </p:sp>
    </p:spTree>
    <p:extLst>
      <p:ext uri="{BB962C8B-B14F-4D97-AF65-F5344CB8AC3E}">
        <p14:creationId xmlns:p14="http://schemas.microsoft.com/office/powerpoint/2010/main" val="7124697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Recovering from a SLIP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44A8DF1-4B07-4B8C-977A-BC6A0A9D36CB}"/>
              </a:ext>
            </a:extLst>
          </p:cNvPr>
          <p:cNvSpPr txBox="1"/>
          <p:nvPr/>
        </p:nvSpPr>
        <p:spPr>
          <a:xfrm>
            <a:off x="1752600" y="2070118"/>
            <a:ext cx="12801600" cy="80329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600" dirty="0"/>
              <a:t>Everybody SLIPS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3200" dirty="0"/>
              <a:t>In fact, we learn from our slips!</a:t>
            </a:r>
          </a:p>
          <a:p>
            <a:pPr lvl="2"/>
            <a:endParaRPr lang="en-US" sz="3200" dirty="0"/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200" dirty="0"/>
              <a:t>A one-time slip won’t hurt, don’t quit!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3200" dirty="0"/>
              <a:t>Take charge after a slip, it won’t defeat you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/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200" dirty="0"/>
              <a:t>Tell those negative thoughts WHO IS BOSS! 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3200" dirty="0"/>
              <a:t>You are the boss, talk back to negative thoughts, </a:t>
            </a:r>
          </a:p>
          <a:p>
            <a:pPr lvl="2"/>
            <a:r>
              <a:rPr lang="en-US" sz="3200" dirty="0"/>
              <a:t>	tell them they are wrong and you are right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/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200" dirty="0"/>
              <a:t>Examine what happened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3200" dirty="0"/>
              <a:t>What can we learn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3200" dirty="0"/>
              <a:t>What can we prevent and predict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3200" dirty="0"/>
              <a:t>What can we change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/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200" dirty="0"/>
              <a:t>Remember your success so far. It’s a process, let’s keep going!</a:t>
            </a:r>
          </a:p>
        </p:txBody>
      </p:sp>
      <p:pic>
        <p:nvPicPr>
          <p:cNvPr id="3074" name="Picture 2" descr="Banana peel">
            <a:extLst>
              <a:ext uri="{FF2B5EF4-FFF2-40B4-BE49-F238E27FC236}">
                <a16:creationId xmlns:a16="http://schemas.microsoft.com/office/drawing/2014/main" id="{0BAACC74-2208-46C1-9116-D6A5F3A8494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01400" y="2757178"/>
            <a:ext cx="6362700" cy="4772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688956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Example: Sadie’s Slip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576628" y="1857730"/>
            <a:ext cx="151347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b="1" u="sng" dirty="0">
                <a:latin typeface="Assistant Regular" charset="-79"/>
                <a:cs typeface="Assistant Regular" charset="-79"/>
              </a:rPr>
              <a:t>Let’s Look at an example (page 5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BD3C406-519B-4BFD-B23C-F0A0C0C59ACC}"/>
              </a:ext>
            </a:extLst>
          </p:cNvPr>
          <p:cNvSpPr txBox="1"/>
          <p:nvPr/>
        </p:nvSpPr>
        <p:spPr>
          <a:xfrm>
            <a:off x="2895600" y="8723630"/>
            <a:ext cx="138157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Break the chain!  Don’t let one slip become 5.  Recognize the slip, learn from it, forgive it, and move on.  You are on a healthy lifestyle, not a diet.  Life happens!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EBE2BE-348F-44C2-A25A-8FEA42265502}"/>
              </a:ext>
            </a:extLst>
          </p:cNvPr>
          <p:cNvSpPr txBox="1"/>
          <p:nvPr/>
        </p:nvSpPr>
        <p:spPr>
          <a:xfrm>
            <a:off x="1828800" y="2933700"/>
            <a:ext cx="14173200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sz="3600" dirty="0"/>
              <a:t>What happened in #1? Was this a HIGH-RISK situation?</a:t>
            </a:r>
          </a:p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sz="3600" dirty="0"/>
              <a:t>What happened in #2? </a:t>
            </a:r>
          </a:p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sz="3600" dirty="0"/>
              <a:t>What happened in #3, and how did Sadie respond?</a:t>
            </a:r>
          </a:p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sz="3600" dirty="0"/>
              <a:t>What could Sadie have done differently?</a:t>
            </a:r>
          </a:p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sz="3600" dirty="0"/>
              <a:t>How did Sadie get back on track?</a:t>
            </a:r>
          </a:p>
          <a:p>
            <a:pPr marL="342900" indent="-342900">
              <a:buAutoNum type="arabicPeriod"/>
            </a:pPr>
            <a:endParaRPr lang="en-US" dirty="0"/>
          </a:p>
        </p:txBody>
      </p:sp>
      <p:pic>
        <p:nvPicPr>
          <p:cNvPr id="26" name="Graphic 25" descr="Link with solid fill">
            <a:extLst>
              <a:ext uri="{FF2B5EF4-FFF2-40B4-BE49-F238E27FC236}">
                <a16:creationId xmlns:a16="http://schemas.microsoft.com/office/drawing/2014/main" id="{1BA6EF9C-F2AE-43D0-BA7A-EE33ED3E5A9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172056" y="8479351"/>
            <a:ext cx="1629274" cy="1629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08957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elf-Defeating Thought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629256" y="2065370"/>
            <a:ext cx="15287144" cy="83407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u="sng" dirty="0">
                <a:latin typeface="Assistant Regular" charset="-79"/>
                <a:cs typeface="Assistant Regular" charset="-79"/>
              </a:rPr>
              <a:t>Everyone has these, but we are in charge of how we respond</a:t>
            </a:r>
          </a:p>
          <a:p>
            <a:endParaRPr lang="en-US" sz="3600" u="sng" dirty="0">
              <a:latin typeface="Assistant Regular" charset="-79"/>
              <a:cs typeface="Assistant Regular" charset="-79"/>
            </a:endParaRPr>
          </a:p>
          <a:p>
            <a:r>
              <a:rPr lang="en-US" sz="3600" dirty="0">
                <a:latin typeface="Assistant Regular" charset="-79"/>
                <a:cs typeface="Assistant Regular" charset="-79"/>
              </a:rPr>
              <a:t>Examples:</a:t>
            </a: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	1) All or Nothing</a:t>
            </a: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	2) Excuses and Rationalization</a:t>
            </a: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	3) </a:t>
            </a:r>
            <a:r>
              <a:rPr lang="en-US" sz="3600" b="1" dirty="0" err="1">
                <a:latin typeface="Assistant Regular" charset="-79"/>
                <a:cs typeface="Assistant Regular" charset="-79"/>
              </a:rPr>
              <a:t>Shoulda</a:t>
            </a:r>
            <a:r>
              <a:rPr lang="en-US" sz="3600" b="1" dirty="0">
                <a:latin typeface="Assistant Regular" charset="-79"/>
                <a:cs typeface="Assistant Regular" charset="-79"/>
              </a:rPr>
              <a:t> </a:t>
            </a:r>
            <a:r>
              <a:rPr lang="en-US" sz="3600" b="1" dirty="0" err="1">
                <a:latin typeface="Assistant Regular" charset="-79"/>
                <a:cs typeface="Assistant Regular" charset="-79"/>
              </a:rPr>
              <a:t>Coulda</a:t>
            </a:r>
            <a:r>
              <a:rPr lang="en-US" sz="3600" b="1" dirty="0">
                <a:latin typeface="Assistant Regular" charset="-79"/>
                <a:cs typeface="Assistant Regular" charset="-79"/>
              </a:rPr>
              <a:t> </a:t>
            </a:r>
            <a:r>
              <a:rPr lang="en-US" sz="3600" b="1" dirty="0" err="1">
                <a:latin typeface="Assistant Regular" charset="-79"/>
                <a:cs typeface="Assistant Regular" charset="-79"/>
              </a:rPr>
              <a:t>Woulda</a:t>
            </a:r>
            <a:endParaRPr lang="en-US" sz="36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	4) Comparing yourself to others </a:t>
            </a:r>
            <a:r>
              <a:rPr lang="en-US" sz="2800" b="1" dirty="0">
                <a:latin typeface="Assistant Regular" charset="-79"/>
                <a:cs typeface="Assistant Regular" charset="-79"/>
              </a:rPr>
              <a:t>(or yourself in the past!)</a:t>
            </a:r>
            <a:endParaRPr lang="en-US" sz="36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	5) Giving up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TALK BACK!</a:t>
            </a:r>
          </a:p>
          <a:p>
            <a:pPr marL="971550" lvl="1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 AWARE that it is happening.</a:t>
            </a:r>
          </a:p>
          <a:p>
            <a:pPr marL="971550" lvl="1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ay STOP! Out loud or in your head.</a:t>
            </a:r>
          </a:p>
          <a:p>
            <a:pPr marL="971550" lvl="1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ut loud or in your head, review your successes and replace negative thoughts with positive ones. Celebrate your successes to defeat the self-defeating thoughts.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13" name="Picture 12" descr="Torn rope">
            <a:extLst>
              <a:ext uri="{FF2B5EF4-FFF2-40B4-BE49-F238E27FC236}">
                <a16:creationId xmlns:a16="http://schemas.microsoft.com/office/drawing/2014/main" id="{8844293E-7373-4E34-9566-B010CFF140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19028" y="3595675"/>
            <a:ext cx="4764385" cy="31779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696536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TAKE BACK YOUR THOUGHTS! Positivit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464743" y="1782350"/>
            <a:ext cx="15854157" cy="65556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b="1" u="sng" dirty="0">
                <a:latin typeface="Assistant Regular" charset="-79"/>
                <a:cs typeface="Assistant Regular" charset="-79"/>
              </a:rPr>
              <a:t>Try these positive messages when negativity creeps in:</a:t>
            </a: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ALL OR NOTHING</a:t>
            </a:r>
            <a:r>
              <a:rPr lang="en-US" sz="36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  “I’m aiming for balance”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24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Don't expect perfection, but don't indulge yourself either. Work toward an overall balance.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Excuses </a:t>
            </a:r>
            <a:r>
              <a:rPr lang="en-US" sz="36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 “Being healthy is worth my effort”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2400" dirty="0">
                <a:latin typeface="Assistant" pitchFamily="2" charset="-79"/>
                <a:cs typeface="Assistant" pitchFamily="2" charset="-79"/>
              </a:rPr>
              <a:t>Instead of distractions &amp; blame, why not give yourself a chance? You just might succeed.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600" dirty="0" err="1">
                <a:latin typeface="Assistant" pitchFamily="2" charset="-79"/>
                <a:cs typeface="Assistant" pitchFamily="2" charset="-79"/>
              </a:rPr>
              <a:t>Shouldas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 </a:t>
            </a:r>
            <a:r>
              <a:rPr lang="en-US" sz="36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 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“It’s my choice, and I choose it now”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2400" dirty="0">
                <a:latin typeface="Assistant" pitchFamily="2" charset="-79"/>
                <a:cs typeface="Assistant" pitchFamily="2" charset="-79"/>
              </a:rPr>
              <a:t>You are in charge. No one else is responsible. No one is setting unrealistic expectations.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Comparing </a:t>
            </a:r>
            <a:r>
              <a:rPr lang="en-US" sz="36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 “Everyone is different”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24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You are going to be the best version of YOU.  Everyone has their own struggles.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Giving Up  “One step at a time”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2400" dirty="0">
                <a:latin typeface="Assistant" pitchFamily="2" charset="-79"/>
                <a:cs typeface="Assistant" pitchFamily="2" charset="-79"/>
              </a:rPr>
              <a:t>Problem-solving is a process. It takes time to make life-long changes. 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2400" dirty="0">
                <a:latin typeface="Assistant" pitchFamily="2" charset="-79"/>
                <a:cs typeface="Assistant" pitchFamily="2" charset="-79"/>
              </a:rPr>
              <a:t>Learn from what doesn't work and if it doesn’t’ try something else. 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2400" dirty="0">
                <a:latin typeface="Assistant" pitchFamily="2" charset="-79"/>
                <a:cs typeface="Assistant" pitchFamily="2" charset="-79"/>
              </a:rPr>
              <a:t>Learning is always a success.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6" name="Graphic 5" descr="Scribble outline">
            <a:extLst>
              <a:ext uri="{FF2B5EF4-FFF2-40B4-BE49-F238E27FC236}">
                <a16:creationId xmlns:a16="http://schemas.microsoft.com/office/drawing/2014/main" id="{4130DCAF-3ED2-4F4B-A76E-52458151A6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576628" y="8913248"/>
            <a:ext cx="1266345" cy="126634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44FE8E7-EF1F-47E6-BEDF-66721E87FA53}"/>
              </a:ext>
            </a:extLst>
          </p:cNvPr>
          <p:cNvSpPr txBox="1"/>
          <p:nvPr/>
        </p:nvSpPr>
        <p:spPr>
          <a:xfrm>
            <a:off x="2895599" y="9069368"/>
            <a:ext cx="937260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THIS WEEK: Keep track of your positive thoughts and times when you STOPPED those negative and self-defeating thoughts.</a:t>
            </a:r>
          </a:p>
        </p:txBody>
      </p:sp>
      <p:pic>
        <p:nvPicPr>
          <p:cNvPr id="5" name="Graphic 4" descr="Chat with solid fill">
            <a:extLst>
              <a:ext uri="{FF2B5EF4-FFF2-40B4-BE49-F238E27FC236}">
                <a16:creationId xmlns:a16="http://schemas.microsoft.com/office/drawing/2014/main" id="{5107DAEE-A81F-45E5-9DF9-9276008BB3E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3639800" y="6591300"/>
            <a:ext cx="914400" cy="9144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6D10BDA-C959-4409-BEED-3608A8C03049}"/>
              </a:ext>
            </a:extLst>
          </p:cNvPr>
          <p:cNvSpPr txBox="1"/>
          <p:nvPr/>
        </p:nvSpPr>
        <p:spPr>
          <a:xfrm>
            <a:off x="14554201" y="6896100"/>
            <a:ext cx="321722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Hit those negative thoughts with your best shot! Put other talk back ideas in the chat!</a:t>
            </a:r>
          </a:p>
        </p:txBody>
      </p:sp>
    </p:spTree>
    <p:extLst>
      <p:ext uri="{BB962C8B-B14F-4D97-AF65-F5344CB8AC3E}">
        <p14:creationId xmlns:p14="http://schemas.microsoft.com/office/powerpoint/2010/main" val="185439460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does progress feel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0759824" cy="6001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How does it feel to be moving towards your goals? (select one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Very Goo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oo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ometimes good, sometimes ba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a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Very Ba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1416" y="8717340"/>
            <a:ext cx="15468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 </a:t>
            </a:r>
          </a:p>
          <a:p>
            <a:r>
              <a:rPr lang="en-US" sz="2400" dirty="0"/>
              <a:t>Feeling good is important. If you are feeling bad about being able to meet your goals, reach out to your Intervention Team and we will make sure to find a way to work together to feel better.  Feeling good is often the missing ingredient!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2052" name="Picture 4" descr="Person running across leaf littered surface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469004" y="3390900"/>
            <a:ext cx="5679325" cy="379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635558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44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Talk Back </a:t>
            </a:r>
            <a:r>
              <a:rPr lang="en-US" sz="3200" b="1">
                <a:latin typeface="Assistant" pitchFamily="2" charset="-79"/>
                <a:cs typeface="Assistant" pitchFamily="2" charset="-79"/>
              </a:rPr>
              <a:t>to Negativity!</a:t>
            </a:r>
            <a:endParaRPr lang="en-US" sz="3200" b="1" dirty="0">
              <a:latin typeface="Assistant" pitchFamily="2" charset="-79"/>
              <a:cs typeface="Assistant" pitchFamily="2" charset="-79"/>
            </a:endParaRP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weight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120 min of exercise this week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lready at 120 minutes? Can you make it to 140 minutes? How about 150?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Use your activity planner and record your 10min+ success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Defeat NEGATIVITY use Positive thoughts to conquer self-defeating ones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rite down your success overcoming negative thoughts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Remember how great you are doing, you got this!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382348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Commitment is everything</a:t>
            </a:r>
          </a:p>
          <a:p>
            <a:r>
              <a:rPr lang="en-US" sz="2800" dirty="0"/>
              <a:t>You have the power to reach your goals, and staying committed over time will get you there. A day or a week can set you back BUT you can always keep going to reach your goals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e your physical activity! 2,000 more steps than last week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7770347"/>
            <a:ext cx="11554505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How many more steps this week than last? Can you keep growing?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Honor your bad feelings and your good ones, but don’t let the bad ones control you. You are in charge, and feeling good is a better foundation for healthy changes.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weight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xplore Fitbit, and calculate your 100 steps and 20 feet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o you prefer heartbeat, breathing or RPE to measure intensity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supports your succes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1445624" cy="79714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have you done to support your healthy lifestyle? (select all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ought new exercise clothing or equipmen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ought healthy food at the stor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ogged all my meal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ogged all my exercis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Used my Fitbit every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Come to the group sessions every week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ighed myself every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Kept my calories at my target most day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ed my walking ti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2526" y="8933563"/>
            <a:ext cx="15468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 </a:t>
            </a:r>
          </a:p>
          <a:p>
            <a:r>
              <a:rPr lang="en-US" sz="2400" dirty="0"/>
              <a:t>Everything you do helps move you towards your goal, you should be proud of the work you have done!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2052" name="Picture 4" descr="Person playing hopscotch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854643" y="3390900"/>
            <a:ext cx="6628770" cy="4419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has your lifestyle changed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0479651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Over the last 2 months, how has your lifestyle changed:</a:t>
            </a:r>
          </a:p>
          <a:p>
            <a:endParaRPr lang="en-US" sz="3200" b="1" u="sng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I now have a healthier diet (Select one)</a:t>
            </a: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diet is the same as befor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diet is only a small amount healthier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diet is moderately bett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 My diet is better on most days, or most meal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diet is a lot bett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diet is totally healthy now compared to bef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diet is a bit worse than bef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diet is a lot worse than bef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Red apple on blue weighing scale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469691" y="3390900"/>
            <a:ext cx="5677950" cy="379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Calendar flipping">
            <a:extLst>
              <a:ext uri="{FF2B5EF4-FFF2-40B4-BE49-F238E27FC236}">
                <a16:creationId xmlns:a16="http://schemas.microsoft.com/office/drawing/2014/main" id="{BD98646B-55E2-46DA-9852-ABD8E5CB9A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439400" y="3272572"/>
            <a:ext cx="6964729" cy="4648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177529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has your lifestyle changed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0479651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Over the last 2 months, how has your lifestyle changed:</a:t>
            </a:r>
          </a:p>
          <a:p>
            <a:endParaRPr lang="en-US" sz="3200" b="1" u="sng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I now have more physical activity(Select one)</a:t>
            </a: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activity is the same as befor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activity has only slightly increase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activity has moderately increase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 My activity is better on most day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activity is a lot more frequent and intensiv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activity is completely different and bett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activity is slightly lower than bef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activity is a lot lower than bef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Red apple on blue weighing scale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469691" y="3390900"/>
            <a:ext cx="5677950" cy="379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Calendar flipping">
            <a:extLst>
              <a:ext uri="{FF2B5EF4-FFF2-40B4-BE49-F238E27FC236}">
                <a16:creationId xmlns:a16="http://schemas.microsoft.com/office/drawing/2014/main" id="{BD98646B-55E2-46DA-9852-ABD8E5CB9A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439400" y="3272572"/>
            <a:ext cx="6964729" cy="4648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417499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Your target weight goal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36550" y="2000926"/>
            <a:ext cx="14601344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aily Weight fluctuate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hink of your current weight as  within 2.5 pounds + or –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is the BMI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measurements: Hip to waist, and Waist to Height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b="1" dirty="0">
                <a:latin typeface="Assistant Regular" charset="-79"/>
                <a:cs typeface="Assistant Regular" charset="-79"/>
              </a:rPr>
              <a:t>We are aiming for 150 min of physical activity a week- where are we now?</a:t>
            </a: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on’t stop at 150, keep going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for ½ of total exercise time in MODERAT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et new challenges, longer distances, longer continuous tim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7324" y="8204909"/>
            <a:ext cx="15468600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BE PROUD of where you are now!</a:t>
            </a:r>
          </a:p>
          <a:p>
            <a:r>
              <a:rPr lang="en-US" sz="2800" dirty="0"/>
              <a:t>There’s always room for improvement, but  you are here which means you are on the road to success! Keep showing up- that’s the most important thing.  Showing up here is a strong part of staying committed and means you are much more likely to reach your goals.</a:t>
            </a:r>
          </a:p>
          <a:p>
            <a:endParaRPr lang="en-US" sz="2000" dirty="0"/>
          </a:p>
        </p:txBody>
      </p:sp>
      <p:pic>
        <p:nvPicPr>
          <p:cNvPr id="5" name="Graphic 4" descr="Cheers with solid fill">
            <a:extLst>
              <a:ext uri="{FF2B5EF4-FFF2-40B4-BE49-F238E27FC236}">
                <a16:creationId xmlns:a16="http://schemas.microsoft.com/office/drawing/2014/main" id="{E453062F-0802-4E53-B731-7167D3C0EE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31914" y="8642746"/>
            <a:ext cx="1449285" cy="14492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DCC4AC5-8CF7-4DC4-95B1-9572B6938029}"/>
              </a:ext>
            </a:extLst>
          </p:cNvPr>
          <p:cNvSpPr txBox="1"/>
          <p:nvPr/>
        </p:nvSpPr>
        <p:spPr>
          <a:xfrm>
            <a:off x="1467769" y="1879074"/>
            <a:ext cx="160019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 Regular" charset="-79"/>
                <a:cs typeface="Assistant Regular" charset="-79"/>
              </a:rPr>
              <a:t>We aimed for 7% reduction of body weight- where are we now?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40933439-A155-4E3D-99C4-0961FFC9385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238" r="14720"/>
          <a:stretch/>
        </p:blipFill>
        <p:spPr>
          <a:xfrm>
            <a:off x="14319348" y="2023786"/>
            <a:ext cx="3242768" cy="47658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do you plan to add next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0479651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In the next week, what will you do to keep moving towards your goals? (select all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igh everyday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ake my shake everyday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og my calories and fat carefull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y a new recip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ring a recipe to the group to sha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Pick a new place to walk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chedule a walk with friend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2526" y="8933563"/>
            <a:ext cx="15468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 </a:t>
            </a:r>
          </a:p>
          <a:p>
            <a:r>
              <a:rPr lang="en-US" sz="2400" dirty="0"/>
              <a:t>Each week add at least one more thing, and you will get to the finish line! Look at the Build Better Meals materials starting page 14 in the handout!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2052" name="Picture 4" descr="Red apple on blue weighing scale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469691" y="3390900"/>
            <a:ext cx="5677950" cy="379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How to set and achieve project milestones in Teamwork Projects">
            <a:extLst>
              <a:ext uri="{FF2B5EF4-FFF2-40B4-BE49-F238E27FC236}">
                <a16:creationId xmlns:a16="http://schemas.microsoft.com/office/drawing/2014/main" id="{BD98646B-55E2-46DA-9852-ABD8E5CB9A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63201" y="3390900"/>
            <a:ext cx="7315200" cy="411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959177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Forgiving SLIPS in your healthy pla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445792" y="2157243"/>
            <a:ext cx="8384008" cy="7848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71500" indent="-571500">
              <a:buFont typeface="Arial" panose="020B0604020202020204" pitchFamily="34" charset="0"/>
              <a:buChar char="•"/>
            </a:pPr>
            <a:r>
              <a:rPr lang="en-US" sz="3600" dirty="0"/>
              <a:t>No one is going to be perfect in diet or exercise all the time: </a:t>
            </a:r>
          </a:p>
          <a:p>
            <a:pPr algn="ctr"/>
            <a:r>
              <a:rPr lang="en-US" sz="3600" b="1" dirty="0"/>
              <a:t>EXPECT TO FALL and EXPECT TO GET BACK UP AND KEEP GOING!</a:t>
            </a:r>
          </a:p>
          <a:p>
            <a:pPr marL="571500" indent="-571500">
              <a:buFont typeface="Arial" panose="020B0604020202020204" pitchFamily="34" charset="0"/>
              <a:buChar char="•"/>
            </a:pPr>
            <a:r>
              <a:rPr lang="en-US" sz="3600" dirty="0"/>
              <a:t>You can’t always prevent or predict when you’ll slip, BUT you can control how you react to that slip.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600" dirty="0"/>
              <a:t>Some slips are predictable and preventable though, </a:t>
            </a:r>
            <a:r>
              <a:rPr lang="en-US" sz="3600" b="1" u="sng" dirty="0"/>
              <a:t>let’s discuss</a:t>
            </a:r>
            <a:r>
              <a:rPr lang="en-US" sz="3600" dirty="0"/>
              <a:t>.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600" dirty="0"/>
              <a:t>When you slip, how can you recover, </a:t>
            </a:r>
            <a:r>
              <a:rPr lang="en-US" sz="3600" b="1" u="sng" dirty="0"/>
              <a:t>lets discuss</a:t>
            </a:r>
            <a:r>
              <a:rPr lang="en-US" sz="3600" dirty="0"/>
              <a:t>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600" dirty="0"/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600" dirty="0"/>
          </a:p>
          <a:p>
            <a:pPr lvl="1"/>
            <a:endParaRPr lang="en-US" sz="3600" dirty="0"/>
          </a:p>
        </p:txBody>
      </p:sp>
      <p:pic>
        <p:nvPicPr>
          <p:cNvPr id="13" name="Graphic 12" descr="Downhill skiing outline">
            <a:extLst>
              <a:ext uri="{FF2B5EF4-FFF2-40B4-BE49-F238E27FC236}">
                <a16:creationId xmlns:a16="http://schemas.microsoft.com/office/drawing/2014/main" id="{4B47F49B-00C7-4DDA-85AB-1C73A1AD44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/>
          <a:stretch/>
        </p:blipFill>
        <p:spPr>
          <a:xfrm>
            <a:off x="9757858" y="7353300"/>
            <a:ext cx="1962667" cy="196266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FB2F016-5DD2-47B8-900D-0D04084224C9}"/>
              </a:ext>
            </a:extLst>
          </p:cNvPr>
          <p:cNvSpPr txBox="1"/>
          <p:nvPr/>
        </p:nvSpPr>
        <p:spPr>
          <a:xfrm>
            <a:off x="11712278" y="7810500"/>
            <a:ext cx="579517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When you ski, you’re bound to fall sometimes.  We know that going in but it is still fun to keep trying.  </a:t>
            </a:r>
          </a:p>
        </p:txBody>
      </p:sp>
      <p:pic>
        <p:nvPicPr>
          <p:cNvPr id="2050" name="Picture 2" descr="Skis in snow on mountain top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881413" y="2958280"/>
            <a:ext cx="5456903" cy="3637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en are you most likely to slip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445792" y="2157243"/>
            <a:ext cx="10266486" cy="72943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Different situations may be more and less difficult for you to stay on track of healthy eating--- choose one:</a:t>
            </a:r>
          </a:p>
          <a:p>
            <a:endParaRPr lang="en-US" sz="3600" dirty="0"/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sad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bored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upset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lonely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you are under pressure/ stressed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When there’s a change to your routine (travel </a:t>
            </a:r>
            <a:r>
              <a:rPr lang="en-US" sz="3600" dirty="0" err="1"/>
              <a:t>etc</a:t>
            </a:r>
            <a:r>
              <a:rPr lang="en-US" sz="3600" dirty="0"/>
              <a:t>)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/>
              <a:t>Other (discuss)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600" dirty="0"/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600" dirty="0"/>
          </a:p>
          <a:p>
            <a:pPr lvl="1"/>
            <a:endParaRPr lang="en-US" sz="3600" dirty="0"/>
          </a:p>
        </p:txBody>
      </p:sp>
      <p:pic>
        <p:nvPicPr>
          <p:cNvPr id="2050" name="Picture 2" descr="Mountain climber summiting snowy peak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881413" y="2961699"/>
            <a:ext cx="5456903" cy="36310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38634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59</TotalTime>
  <Words>1746</Words>
  <Application>Microsoft Office PowerPoint</Application>
  <PresentationFormat>Custom</PresentationFormat>
  <Paragraphs>271</Paragraphs>
  <Slides>17</Slides>
  <Notes>16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6" baseType="lpstr">
      <vt:lpstr>Courier New</vt:lpstr>
      <vt:lpstr>Assistant SemiBold</vt:lpstr>
      <vt:lpstr>Assistant Bold</vt:lpstr>
      <vt:lpstr>Assistant</vt:lpstr>
      <vt:lpstr>Assistant Regular</vt:lpstr>
      <vt:lpstr>Assistant ExtraBold</vt:lpstr>
      <vt:lpstr>Calibri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300</cp:revision>
  <dcterms:created xsi:type="dcterms:W3CDTF">2006-08-16T00:00:00Z</dcterms:created>
  <dcterms:modified xsi:type="dcterms:W3CDTF">2023-11-03T20:53:22Z</dcterms:modified>
  <dc:identifier>DAE7nbwep5o</dc:identifier>
</cp:coreProperties>
</file>